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A36C0F-2BE5-4FD0-A4B3-681E872A23D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949C2B-68C8-40DC-A88F-4982EBBF16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ECD563-17E7-42E2-B4C9-2BA61B389A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07024-582C-48A2-AC60-9ECF6689744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10D1D7-4F37-413D-BEA9-CE50A05D65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FF7EA6-937B-47FC-85E2-02BCB4D1CE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DAD8E-EA2D-4494-B655-368D14DEEE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72394A-9C5D-4DB0-906A-8467620881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690B23-0D6F-44D1-ADB5-BF1AC5D73E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795005-A04F-4B06-A8B8-35CC2CF56A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DCD0BE-FBE0-4E37-BA97-2AAFE53C07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DC3B83-9BB0-417C-A509-31932A416E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ACB77B-29B4-4325-9F01-2F21896ACF2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92040" y="1146240"/>
          <a:ext cx="8370720" cy="4683240"/>
        </p:xfrm>
        <a:graphic>
          <a:graphicData uri="http://schemas.openxmlformats.org/drawingml/2006/table">
            <a:tbl>
              <a:tblPr/>
              <a:tblGrid>
                <a:gridCol w="1208160"/>
                <a:gridCol w="3504960"/>
                <a:gridCol w="3657600"/>
              </a:tblGrid>
              <a:tr h="26820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e na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rward primer sequenc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verse primer sequenc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1608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PD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TGTCCGTCGTGGATCTG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GCTGTTGAAGTCGCAGG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080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K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GTGGAGAAGATTGGAGA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CGTCAACTTGTTTTTGGC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676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K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CTCTTCTCACTCTGCG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CCAGAGATGGAGGAGTC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028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K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ACACTGTGCACACATCAA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ACCAGTGAGGAGGGCA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560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yclin D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GTACCCTGACACCAATC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CCTCTTCGCACTTCTGC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44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yclin D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GTGGGAACTGGTAGTGTT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GCACAGAGCGATGAAGG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184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yclin D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GAGCCTCCTACTTCCAGT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ACAGGTAGCGATCCAGG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yclin G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GGGTTCAGCTTTTCGGAT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TGTTATCATTCTCCGGGGT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884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GAATTTGCGACGCTGT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CTTCCTCCCACCCTCCT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704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ATGAAGCACACAGCCTGCAATG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GGACAGCCAACCAACTAAC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196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TGGAAGAAGCGAGTCAG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GAAGAAGAATCTTCTGC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232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GGAAAGCCCTGCAATTTA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TGTCTGGAACCTCAATTCTG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168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ATCCTGGTGATGTCCGA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GCAGAAGACCAATCTGC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56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5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AGATCCGCGGGCGTA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TCCTTTAACTCTAAGGCCTCAT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GR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GGCTCCTTTCCTCACT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CATAGGGTTGTTCGCTC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GGGCAAAGTAGAGCAGC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ATCTCAGTCTGCAACG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06T01:30:27Z</dcterms:created>
  <dc:creator>江传和</dc:creator>
  <dc:description/>
  <dc:language>en-US</dc:language>
  <cp:lastModifiedBy/>
  <dcterms:modified xsi:type="dcterms:W3CDTF">2015-06-18T13:56:52Z</dcterms:modified>
  <cp:revision>0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5108</vt:lpwstr>
  </property>
</Properties>
</file>